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0" autoAdjust="0"/>
    <p:restoredTop sz="94660"/>
  </p:normalViewPr>
  <p:slideViewPr>
    <p:cSldViewPr snapToGrid="0">
      <p:cViewPr varScale="1">
        <p:scale>
          <a:sx n="98" d="100"/>
          <a:sy n="98" d="100"/>
        </p:scale>
        <p:origin x="6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8B9193-8C8D-45AD-8571-C16A46B0E5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5D25E8-DCED-4C90-8F1A-B44C91D28C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A290F4-937D-43F8-9A75-6885E37D0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EB8526-CD9F-4BC7-9F40-188B16998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0D43A7-F151-4AE5-AA33-502307E9D6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434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206787-417A-4BFE-8270-FF4CF3FA4E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781892-9902-4C41-9CDC-9D17616370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39BDB4-9216-4BDA-B9AC-E0C7F6285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827F31-60BF-4FB0-B86B-A6EF3133A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A740DC-3CF4-426C-BB1B-417D44D3A4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300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63BD7D-C75D-4DE4-B418-5058F78B8F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CA3E4C-5B6B-4FCB-9117-09A2465A96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89C3C8-2A5D-4384-962C-1ACCB0A1E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B672D6-C906-4668-BCEB-1EE485C663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9AD3A2-483E-4433-8239-0071C546E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521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9122DD-20D6-4DBE-A80F-F3706DD596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F2976D-E61E-44C6-9201-118017FCD2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3FF8EB-D357-4DBE-9092-D369E27F3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15DF81-C33C-40B6-B81F-4FDD00F11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1D5082-B5CE-4598-B95A-1E8F643EC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1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731C01-BB98-416A-A077-F07B666253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9E8B66-EBA9-435C-B388-B6DDCD308F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8981B3-8372-4349-9EEE-3FA3896879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E700EC-43F8-49E4-8BA1-BD0598425B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FD38B0-EF26-42C3-BD2D-2E3F86DE7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839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CED26-492B-4175-880D-1E09EAAC27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97DC83-D8E1-4723-8549-B32A2FCAAD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A46559-9C9C-4F97-9458-433067AA85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6AA0ED-FE0D-4A5C-884B-007ED0E3F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2E0CA3-2535-4FBD-B4EC-481579718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5A54CE-3ED1-4536-9B4F-EBE0F578A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584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7ECC0-C99B-411C-BEE5-E49E24A76D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26E02B-561F-4B8B-9CD2-9D37DDE890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58B680-F57B-4721-8203-A9EEBEE549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ECDAA07-D2A5-4DE3-8303-6A4506C7A3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F49BEC-2710-4BE8-A276-1C56963910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B783C28-3CC4-4933-8228-CF5704B26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836274-4E96-4AAC-9536-232786516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F971B84-303B-493C-A6B7-9BA7D1446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460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F72A88-40B2-4A65-8A73-C8FF92BE86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99FCA6B-1D71-4B3E-9831-4A1A4E366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5236C2-9A6B-4464-ACA0-6A502A15A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660ED8-A744-4BD1-9921-9E4247C8F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307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8A07839-E180-46CE-B5C0-11197E80CB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49DEEC4-0146-45C9-963A-D2544BA3C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25A994-7F25-4E3C-886A-53C32FA32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350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80A8BB-DB42-45D9-AED5-CAF62D4E94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847BF7-0E4A-407F-80E1-3F78BAD88C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0AE7FE-E04E-4739-8E79-1A66A2DF8C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F957C6-0A98-4113-ACCF-6FA361D68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4FDFA-24A9-4350-BA0A-39DFEA8E44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A39943-878F-4EA5-8AA4-DDA83574EF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618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0D6F43-EC36-47CA-983D-7C87FFBD05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3BCE105-FACD-4456-8B92-C7217345E7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57E7BA-DC58-41EE-B084-3BF9683B97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E0B06B-E4A8-4F0C-9DF5-32AF6FF2F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7CCEB6-3789-48D5-A76F-2931312B0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506452-48A4-43E2-8361-6B2538005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860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9E5208-AE35-430A-AD7E-9F4EC93753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0F8717-AA46-447D-9CF9-B02307D8C4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BD3DCE-CFD8-4515-B9BA-FB1C4CC525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C3017-7145-433C-B612-E486452661CE}" type="datetimeFigureOut">
              <a:rPr lang="en-US" smtClean="0"/>
              <a:t>9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5C4D7-DFA8-45CA-8F9A-45561A8AAB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1385D4-FB38-489E-B6FB-4B46E7E201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6A376D-6C5A-4BA8-9AB6-5567F4079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47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magine 4">
            <a:extLst>
              <a:ext uri="{FF2B5EF4-FFF2-40B4-BE49-F238E27FC236}">
                <a16:creationId xmlns:a16="http://schemas.microsoft.com/office/drawing/2014/main" id="{89E7A6AC-6778-DA4D-8406-D53C0009D8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8879" y="1112855"/>
            <a:ext cx="2982298" cy="4100659"/>
          </a:xfrm>
          <a:prstGeom prst="rect">
            <a:avLst/>
          </a:prstGeom>
        </p:spPr>
      </p:pic>
      <p:pic>
        <p:nvPicPr>
          <p:cNvPr id="14" name="Immagine 6" descr="Immagine che contiene testo, screenshot&#10;&#10;Descrizione generata automaticamente">
            <a:extLst>
              <a:ext uri="{FF2B5EF4-FFF2-40B4-BE49-F238E27FC236}">
                <a16:creationId xmlns:a16="http://schemas.microsoft.com/office/drawing/2014/main" id="{B4B20003-555D-2D48-A09F-A8881FF294D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4917" y="1112854"/>
            <a:ext cx="2982298" cy="4100659"/>
          </a:xfrm>
          <a:prstGeom prst="rect">
            <a:avLst/>
          </a:prstGeom>
        </p:spPr>
      </p:pic>
      <p:sp>
        <p:nvSpPr>
          <p:cNvPr id="18" name="TextBox 14">
            <a:extLst>
              <a:ext uri="{FF2B5EF4-FFF2-40B4-BE49-F238E27FC236}">
                <a16:creationId xmlns:a16="http://schemas.microsoft.com/office/drawing/2014/main" id="{B22DB135-B4E2-3A4D-B8E9-77B9C681A925}"/>
              </a:ext>
            </a:extLst>
          </p:cNvPr>
          <p:cNvSpPr txBox="1"/>
          <p:nvPr/>
        </p:nvSpPr>
        <p:spPr>
          <a:xfrm rot="18646682">
            <a:off x="7838625" y="894235"/>
            <a:ext cx="10866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MCF7 shRNA</a:t>
            </a:r>
          </a:p>
        </p:txBody>
      </p:sp>
      <p:sp>
        <p:nvSpPr>
          <p:cNvPr id="19" name="TextBox 15">
            <a:extLst>
              <a:ext uri="{FF2B5EF4-FFF2-40B4-BE49-F238E27FC236}">
                <a16:creationId xmlns:a16="http://schemas.microsoft.com/office/drawing/2014/main" id="{F0A70D1B-6C0D-E74E-BB17-9A105BCBA32C}"/>
              </a:ext>
            </a:extLst>
          </p:cNvPr>
          <p:cNvSpPr txBox="1"/>
          <p:nvPr/>
        </p:nvSpPr>
        <p:spPr>
          <a:xfrm rot="18646682">
            <a:off x="8080768" y="630429"/>
            <a:ext cx="1801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MCF7 shFTH1 PCDNA</a:t>
            </a:r>
            <a:r>
              <a:rPr lang="en-US" sz="1200" baseline="-25000" dirty="0"/>
              <a:t>3</a:t>
            </a:r>
          </a:p>
        </p:txBody>
      </p:sp>
      <p:sp>
        <p:nvSpPr>
          <p:cNvPr id="20" name="TextBox 16">
            <a:extLst>
              <a:ext uri="{FF2B5EF4-FFF2-40B4-BE49-F238E27FC236}">
                <a16:creationId xmlns:a16="http://schemas.microsoft.com/office/drawing/2014/main" id="{A1E3D1E0-3469-0B4E-9B19-236DC13D42D1}"/>
              </a:ext>
            </a:extLst>
          </p:cNvPr>
          <p:cNvSpPr txBox="1"/>
          <p:nvPr/>
        </p:nvSpPr>
        <p:spPr>
          <a:xfrm rot="18646682">
            <a:off x="8353816" y="485277"/>
            <a:ext cx="2166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MCF7shFTH1/ PCDNA</a:t>
            </a:r>
            <a:r>
              <a:rPr lang="en-US" sz="1200" baseline="-25000" dirty="0"/>
              <a:t>3</a:t>
            </a:r>
            <a:r>
              <a:rPr lang="en-US" sz="1200" dirty="0"/>
              <a:t>FTH1</a:t>
            </a:r>
          </a:p>
        </p:txBody>
      </p:sp>
      <p:sp>
        <p:nvSpPr>
          <p:cNvPr id="21" name="TextBox 27">
            <a:extLst>
              <a:ext uri="{FF2B5EF4-FFF2-40B4-BE49-F238E27FC236}">
                <a16:creationId xmlns:a16="http://schemas.microsoft.com/office/drawing/2014/main" id="{776E7CEE-6B07-6347-A8B4-4FDA7DE2FB7D}"/>
              </a:ext>
            </a:extLst>
          </p:cNvPr>
          <p:cNvSpPr txBox="1"/>
          <p:nvPr/>
        </p:nvSpPr>
        <p:spPr>
          <a:xfrm>
            <a:off x="9674952" y="287432"/>
            <a:ext cx="2276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400" b="1" u="sng" dirty="0"/>
              <a:t>FTH1</a:t>
            </a:r>
          </a:p>
        </p:txBody>
      </p:sp>
      <p:sp>
        <p:nvSpPr>
          <p:cNvPr id="22" name="TextBox 28">
            <a:extLst>
              <a:ext uri="{FF2B5EF4-FFF2-40B4-BE49-F238E27FC236}">
                <a16:creationId xmlns:a16="http://schemas.microsoft.com/office/drawing/2014/main" id="{943C04A0-5C0C-4D44-ADC8-FEC00911C40C}"/>
              </a:ext>
            </a:extLst>
          </p:cNvPr>
          <p:cNvSpPr txBox="1"/>
          <p:nvPr/>
        </p:nvSpPr>
        <p:spPr>
          <a:xfrm>
            <a:off x="4704606" y="316656"/>
            <a:ext cx="2276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400" b="1" u="sng" dirty="0"/>
              <a:t>HSC70</a:t>
            </a:r>
          </a:p>
        </p:txBody>
      </p:sp>
      <p:sp>
        <p:nvSpPr>
          <p:cNvPr id="23" name="Rettangolo 12">
            <a:extLst>
              <a:ext uri="{FF2B5EF4-FFF2-40B4-BE49-F238E27FC236}">
                <a16:creationId xmlns:a16="http://schemas.microsoft.com/office/drawing/2014/main" id="{55491584-F275-6440-BE39-0908B2D6317F}"/>
              </a:ext>
            </a:extLst>
          </p:cNvPr>
          <p:cNvSpPr/>
          <p:nvPr/>
        </p:nvSpPr>
        <p:spPr>
          <a:xfrm>
            <a:off x="7802880" y="1463040"/>
            <a:ext cx="1436813" cy="1187993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5" name="Rettangolo 13">
            <a:extLst>
              <a:ext uri="{FF2B5EF4-FFF2-40B4-BE49-F238E27FC236}">
                <a16:creationId xmlns:a16="http://schemas.microsoft.com/office/drawing/2014/main" id="{9D4ACDCF-282E-7344-B3F6-83197D2E2089}"/>
              </a:ext>
            </a:extLst>
          </p:cNvPr>
          <p:cNvSpPr/>
          <p:nvPr/>
        </p:nvSpPr>
        <p:spPr>
          <a:xfrm>
            <a:off x="3024364" y="1534634"/>
            <a:ext cx="1436813" cy="1187993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26" name="Connettore 2 15">
            <a:extLst>
              <a:ext uri="{FF2B5EF4-FFF2-40B4-BE49-F238E27FC236}">
                <a16:creationId xmlns:a16="http://schemas.microsoft.com/office/drawing/2014/main" id="{3258EDBD-8869-AC4E-A491-4029A39DE0C1}"/>
              </a:ext>
            </a:extLst>
          </p:cNvPr>
          <p:cNvCxnSpPr/>
          <p:nvPr/>
        </p:nvCxnSpPr>
        <p:spPr>
          <a:xfrm flipH="1">
            <a:off x="9316720" y="768928"/>
            <a:ext cx="1209040" cy="9785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7" name="Connettore 2 16">
            <a:extLst>
              <a:ext uri="{FF2B5EF4-FFF2-40B4-BE49-F238E27FC236}">
                <a16:creationId xmlns:a16="http://schemas.microsoft.com/office/drawing/2014/main" id="{80FC9102-D9C1-5D4C-9995-D3071AB4AB58}"/>
              </a:ext>
            </a:extLst>
          </p:cNvPr>
          <p:cNvCxnSpPr/>
          <p:nvPr/>
        </p:nvCxnSpPr>
        <p:spPr>
          <a:xfrm flipH="1">
            <a:off x="4628834" y="973744"/>
            <a:ext cx="1209040" cy="9785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58143354-7A41-5944-8739-1ABB7F116E3E}"/>
              </a:ext>
            </a:extLst>
          </p:cNvPr>
          <p:cNvSpPr txBox="1"/>
          <p:nvPr/>
        </p:nvSpPr>
        <p:spPr>
          <a:xfrm>
            <a:off x="70410" y="21802"/>
            <a:ext cx="390265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err="1"/>
              <a:t>Figura</a:t>
            </a:r>
            <a:r>
              <a:rPr lang="en-US" sz="2400" b="1" dirty="0"/>
              <a:t> 4-source data 1</a:t>
            </a:r>
          </a:p>
          <a:p>
            <a:endParaRPr lang="en-US" sz="2400" b="1" dirty="0"/>
          </a:p>
          <a:p>
            <a:r>
              <a:rPr lang="en-US" sz="2400" b="1" u="sng" dirty="0">
                <a:solidFill>
                  <a:srgbClr val="FF0000"/>
                </a:solidFill>
              </a:rPr>
              <a:t>MCF7</a:t>
            </a:r>
          </a:p>
        </p:txBody>
      </p:sp>
    </p:spTree>
    <p:extLst>
      <p:ext uri="{BB962C8B-B14F-4D97-AF65-F5344CB8AC3E}">
        <p14:creationId xmlns:p14="http://schemas.microsoft.com/office/powerpoint/2010/main" val="2175908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279E982-82C6-7F43-BA3D-E98061436F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56004" y="2640895"/>
            <a:ext cx="4096867" cy="298120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91B423E-2B23-8F45-8632-1A9A9D5E7652}"/>
              </a:ext>
            </a:extLst>
          </p:cNvPr>
          <p:cNvSpPr txBox="1"/>
          <p:nvPr/>
        </p:nvSpPr>
        <p:spPr>
          <a:xfrm rot="18646682">
            <a:off x="7797742" y="3199215"/>
            <a:ext cx="10866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460 shRN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04AA950-C456-C849-8524-D8281A63FE62}"/>
              </a:ext>
            </a:extLst>
          </p:cNvPr>
          <p:cNvSpPr txBox="1"/>
          <p:nvPr/>
        </p:nvSpPr>
        <p:spPr>
          <a:xfrm rot="18646682">
            <a:off x="7900179" y="2928641"/>
            <a:ext cx="1801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460 shFTH1 PCDNA</a:t>
            </a:r>
            <a:r>
              <a:rPr lang="en-US" sz="1200" baseline="-25000" dirty="0"/>
              <a:t>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C4BE003-AB2D-DC4D-B98E-D0990BCBA718}"/>
              </a:ext>
            </a:extLst>
          </p:cNvPr>
          <p:cNvSpPr txBox="1"/>
          <p:nvPr/>
        </p:nvSpPr>
        <p:spPr>
          <a:xfrm rot="18646682">
            <a:off x="8063993" y="2861971"/>
            <a:ext cx="2166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460 shFTH1/ PCDNA</a:t>
            </a:r>
            <a:r>
              <a:rPr lang="en-US" sz="1200" baseline="-25000" dirty="0"/>
              <a:t>3</a:t>
            </a:r>
            <a:r>
              <a:rPr lang="en-US" sz="1200" dirty="0"/>
              <a:t>FTH1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E66C5E1-7E5F-5046-893B-E452FC9313B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5816" y="2563871"/>
            <a:ext cx="4100659" cy="298229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583661B-29BF-084F-A8B4-AD24AE6813B2}"/>
              </a:ext>
            </a:extLst>
          </p:cNvPr>
          <p:cNvSpPr txBox="1"/>
          <p:nvPr/>
        </p:nvSpPr>
        <p:spPr>
          <a:xfrm rot="18646682">
            <a:off x="2493052" y="3237406"/>
            <a:ext cx="10866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460 shRN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65F56A-F0AF-1D40-A62F-1698BEA11CF6}"/>
              </a:ext>
            </a:extLst>
          </p:cNvPr>
          <p:cNvSpPr txBox="1"/>
          <p:nvPr/>
        </p:nvSpPr>
        <p:spPr>
          <a:xfrm rot="18646682">
            <a:off x="2595489" y="2966832"/>
            <a:ext cx="1801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460 shFTH1 PCDNA</a:t>
            </a:r>
            <a:r>
              <a:rPr lang="en-US" sz="1200" baseline="-25000" dirty="0"/>
              <a:t>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E356D95-F54C-D640-AE27-333B214F5BF8}"/>
              </a:ext>
            </a:extLst>
          </p:cNvPr>
          <p:cNvSpPr txBox="1"/>
          <p:nvPr/>
        </p:nvSpPr>
        <p:spPr>
          <a:xfrm rot="18646682">
            <a:off x="2759303" y="2900162"/>
            <a:ext cx="2166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460 shFTH1/ PCDNA</a:t>
            </a:r>
            <a:r>
              <a:rPr lang="en-US" sz="1200" baseline="-25000" dirty="0"/>
              <a:t>3</a:t>
            </a:r>
            <a:r>
              <a:rPr lang="en-US" sz="1200" dirty="0"/>
              <a:t>FTH1</a:t>
            </a:r>
          </a:p>
        </p:txBody>
      </p:sp>
      <p:sp>
        <p:nvSpPr>
          <p:cNvPr id="12" name="TextBox 27">
            <a:extLst>
              <a:ext uri="{FF2B5EF4-FFF2-40B4-BE49-F238E27FC236}">
                <a16:creationId xmlns:a16="http://schemas.microsoft.com/office/drawing/2014/main" id="{4C74079D-A294-914E-81E6-0DAE1E4A70E1}"/>
              </a:ext>
            </a:extLst>
          </p:cNvPr>
          <p:cNvSpPr txBox="1"/>
          <p:nvPr/>
        </p:nvSpPr>
        <p:spPr>
          <a:xfrm>
            <a:off x="9674952" y="823010"/>
            <a:ext cx="2276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400" b="1" u="sng" dirty="0"/>
              <a:t>FTH1</a:t>
            </a:r>
          </a:p>
        </p:txBody>
      </p:sp>
      <p:sp>
        <p:nvSpPr>
          <p:cNvPr id="13" name="TextBox 28">
            <a:extLst>
              <a:ext uri="{FF2B5EF4-FFF2-40B4-BE49-F238E27FC236}">
                <a16:creationId xmlns:a16="http://schemas.microsoft.com/office/drawing/2014/main" id="{7CF4F211-2916-C941-8D9B-E6EFDCAF3D66}"/>
              </a:ext>
            </a:extLst>
          </p:cNvPr>
          <p:cNvSpPr txBox="1"/>
          <p:nvPr/>
        </p:nvSpPr>
        <p:spPr>
          <a:xfrm>
            <a:off x="4704606" y="852234"/>
            <a:ext cx="2276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400" b="1" u="sng" dirty="0"/>
              <a:t>HSC70</a:t>
            </a:r>
          </a:p>
        </p:txBody>
      </p:sp>
      <p:cxnSp>
        <p:nvCxnSpPr>
          <p:cNvPr id="14" name="Connettore 2 15">
            <a:extLst>
              <a:ext uri="{FF2B5EF4-FFF2-40B4-BE49-F238E27FC236}">
                <a16:creationId xmlns:a16="http://schemas.microsoft.com/office/drawing/2014/main" id="{1150556F-D238-4442-B5DF-6FC4BBE207C8}"/>
              </a:ext>
            </a:extLst>
          </p:cNvPr>
          <p:cNvCxnSpPr/>
          <p:nvPr/>
        </p:nvCxnSpPr>
        <p:spPr>
          <a:xfrm flipH="1">
            <a:off x="9316720" y="1304506"/>
            <a:ext cx="1209040" cy="9785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5" name="Connettore 2 16">
            <a:extLst>
              <a:ext uri="{FF2B5EF4-FFF2-40B4-BE49-F238E27FC236}">
                <a16:creationId xmlns:a16="http://schemas.microsoft.com/office/drawing/2014/main" id="{BE03985F-E8AB-604F-9492-59E43E7F4FC9}"/>
              </a:ext>
            </a:extLst>
          </p:cNvPr>
          <p:cNvCxnSpPr/>
          <p:nvPr/>
        </p:nvCxnSpPr>
        <p:spPr>
          <a:xfrm flipH="1">
            <a:off x="4628834" y="1509322"/>
            <a:ext cx="1209040" cy="9785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2B4101EF-FE6B-D644-8313-3938BE3B1338}"/>
              </a:ext>
            </a:extLst>
          </p:cNvPr>
          <p:cNvSpPr txBox="1"/>
          <p:nvPr/>
        </p:nvSpPr>
        <p:spPr>
          <a:xfrm>
            <a:off x="70410" y="21802"/>
            <a:ext cx="390265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err="1"/>
              <a:t>Figura</a:t>
            </a:r>
            <a:r>
              <a:rPr lang="en-US" sz="2400" b="1" dirty="0"/>
              <a:t> 4-source data 1</a:t>
            </a:r>
          </a:p>
          <a:p>
            <a:endParaRPr lang="en-US" sz="2400" b="1" dirty="0"/>
          </a:p>
          <a:p>
            <a:r>
              <a:rPr lang="en-US" sz="2400" b="1" u="sng" dirty="0">
                <a:solidFill>
                  <a:srgbClr val="FF0000"/>
                </a:solidFill>
              </a:rPr>
              <a:t>H460</a:t>
            </a:r>
          </a:p>
        </p:txBody>
      </p:sp>
    </p:spTree>
    <p:extLst>
      <p:ext uri="{BB962C8B-B14F-4D97-AF65-F5344CB8AC3E}">
        <p14:creationId xmlns:p14="http://schemas.microsoft.com/office/powerpoint/2010/main" val="2285300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2</TotalTime>
  <Words>40</Words>
  <Application>Microsoft Macintosh PowerPoint</Application>
  <PresentationFormat>Widescreen</PresentationFormat>
  <Paragraphs>1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Grazia</dc:creator>
  <cp:lastModifiedBy>.. tirinato</cp:lastModifiedBy>
  <cp:revision>13</cp:revision>
  <dcterms:created xsi:type="dcterms:W3CDTF">2021-08-30T14:32:10Z</dcterms:created>
  <dcterms:modified xsi:type="dcterms:W3CDTF">2021-09-05T08:57:33Z</dcterms:modified>
</cp:coreProperties>
</file>